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7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1EB649-17B1-445B-9571-C75DD6D86A0D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CD626F-1705-48DB-9B8E-8CD271D165A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90365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F744CCC-46E9-7688-2906-12A324F574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2DF1E19-1D30-89D4-C038-FEDE434BF9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8FDF715-24E9-8A8D-03D4-96E49FB0F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0F7D212-FB4E-F675-EFD3-6492B3520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79F96C7-42C6-CCCA-0829-A36F041280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9360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6DA2BE-438E-797F-1C1B-321508971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FBEDFDB-8F10-EDB3-ED47-99343C81F2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BA5425B-440F-ADD4-C728-D123F6596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1EB524-E65A-8996-FA1F-4D2776EE5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B666142-4DA1-7399-0F06-0476A6A3E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1298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F8AF0EA-763F-16B9-0DA1-2272E09E12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B74AA9C-7452-6F76-BE88-1D305505E2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769408A-907C-0799-8776-97D72BD96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7144BAD-12EA-093A-335A-B13299F07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594DB88-4D93-7BC4-B8F7-9399EE22D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5329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B264FB-8C8C-8B77-AD45-29C7A20A06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EB5D888-AA6E-3A26-D001-48F00CF697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96E5FF-C1AA-6730-B077-7E7B91C28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3AC8766-0527-C96E-217A-2CD34C2516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0DB8C9-57DD-F3E8-4E9A-70117D53B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1463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82EE6B-A62D-775F-3F06-D3874DAC6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F3CD5FF-E1AE-F736-5BFD-D579B4DB84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0747A06-D3D1-D637-F386-66826CCF5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6E74043-957E-C976-D60F-AD4569097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D9B9396-3966-D835-2CB5-CE2AEB09A8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4172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FF3F15-394A-2ECC-01CB-B08A1B088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3FEA71A-20FD-1D93-2A62-D320EEC633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07982C6-4AE8-FB53-07E0-6AFCF5DF1A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BF801E-0B89-A306-859D-639F9F142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7987191-D381-A152-4D46-19E7FA2FB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451A059-5738-1494-04BC-73A8BC31E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537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ADA289-C419-CCB5-AA3F-6330512BA8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27C1AE2-200E-EF2C-E95E-2675EA3CD3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A1D9646-BB54-D205-A1CD-202444DEDE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9832D20-37FF-3FB8-C7C9-A9CB67018F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62B2674-B7B2-CC37-2B94-CE3865C4DA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D66948B-A594-693B-E59F-F51D6B00A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13E672D-F9B8-2194-6C16-5EBC36777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DF29C2E-0210-5BD0-5EA3-65D2D3EB9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5597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A45253-0887-B3DD-F842-28DAD97BA1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04FD90E-2098-89F7-4349-9CCECF2B8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6FD3444-85A2-7551-3222-C8EDB4BBD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3C033D2-ABB2-D61F-4D7D-18AEF8B2E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4177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8295978-3383-F8B4-E89A-F39231445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8963890-7493-D460-EC6E-9647252BD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ACC12E0-790B-C0AC-A1F4-93ADD7BB4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1091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7C2D9B5-06D2-7FB4-FCB5-0094753F8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5649A2F-3255-E26A-97BF-92F597DD63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C899F36-8162-8267-9764-D8204C1446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F124357-77FD-F663-9F0B-2799E9A89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9BF5596-2FD8-DCBB-DB97-9B1B568AB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BA9956F-2484-C16B-13A9-F3AAD6B94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031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49525B-C8E4-2EFD-348F-F2765DFD8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9E4EF4F-6E0F-E0F4-498F-E84DF2CB93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6B516D2-1FB0-0232-ECA2-F0E8FD7FB7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7B95E26-6710-FAE5-ACB5-78EB9EEF6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0AF0F4-D672-479D-FEC2-BA2E7F749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8355870-B977-5D17-5FED-090E7E75F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6561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ED75A8E-99EC-89DF-C483-080E5096B7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49ED7E6-3BAF-C655-C756-F5AD71F916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F231B9-161B-1F68-EF20-68883F3C1D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53738-110C-4A48-BAED-740DDFE1BD1C}" type="datetimeFigureOut">
              <a:rPr lang="fr-FR" smtClean="0"/>
              <a:t>27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73CDC17-BAAD-52F6-17C1-0C5A1C086B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E632462-D74A-B7A4-69E6-6281B32C99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74445-4689-4A12-98BE-F2DAD84128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1429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Box 51">
            <a:extLst>
              <a:ext uri="{FF2B5EF4-FFF2-40B4-BE49-F238E27FC236}">
                <a16:creationId xmlns:a16="http://schemas.microsoft.com/office/drawing/2014/main" id="{77F4A86A-385B-4E26-B55A-F74B5FD810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47207" y="680493"/>
            <a:ext cx="2392744" cy="3101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/>
            <a:endParaRPr lang="en-US" sz="1200" b="1" dirty="0"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D9BACA98-C22F-4216-B62E-994E407F797A}"/>
              </a:ext>
            </a:extLst>
          </p:cNvPr>
          <p:cNvSpPr txBox="1"/>
          <p:nvPr/>
        </p:nvSpPr>
        <p:spPr>
          <a:xfrm>
            <a:off x="84836" y="72034"/>
            <a:ext cx="245516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Arial" panose="020B0604020202020204" pitchFamily="34" charset="0"/>
                <a:cs typeface="Arial" panose="020B0604020202020204" pitchFamily="34" charset="0"/>
              </a:rPr>
              <a:t>S5a. </a:t>
            </a:r>
            <a:r>
              <a:rPr lang="en-GB" sz="14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thodological assessment of studies using NOS criteria, for c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oss sectional studies</a:t>
            </a:r>
            <a:endParaRPr lang="fr-FR" sz="1400" b="1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08185272-23E7-46E0-AE05-3D46BEEF9A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52380" y="450376"/>
            <a:ext cx="1656745" cy="6020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1487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-Louis Naillon</dc:creator>
  <cp:lastModifiedBy>MDPI</cp:lastModifiedBy>
  <cp:revision>14</cp:revision>
  <dcterms:created xsi:type="dcterms:W3CDTF">2022-05-30T15:13:49Z</dcterms:created>
  <dcterms:modified xsi:type="dcterms:W3CDTF">2023-04-27T12:19:28Z</dcterms:modified>
</cp:coreProperties>
</file>